
<file path=[Content_Types].xml><?xml version="1.0" encoding="utf-8"?>
<Types xmlns="http://schemas.openxmlformats.org/package/2006/content-types">
  <Default Extension="fntdata" ContentType="application/x-fontdata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60" r:id="rId1"/>
  </p:sldMasterIdLst>
  <p:notesMasterIdLst>
    <p:notesMasterId r:id="rId3"/>
  </p:notesMasterIdLst>
  <p:sldIdLst>
    <p:sldId id="276" r:id="rId2"/>
  </p:sldIdLst>
  <p:sldSz cx="6858000" cy="9906000" type="A4"/>
  <p:notesSz cx="6858000" cy="9144000"/>
  <p:embeddedFontLst>
    <p:embeddedFont>
      <p:font typeface="Calibri" panose="020F0502020204030204" pitchFamily="34" charset="0"/>
      <p:regular r:id="rId4"/>
      <p:bold r:id="rId5"/>
      <p:italic r:id="rId6"/>
      <p:boldItalic r:id="rId7"/>
    </p:embeddedFont>
    <p:embeddedFont>
      <p:font typeface="Calibri Light" panose="020F0302020204030204" pitchFamily="34" charset="0"/>
      <p:regular r:id="rId8"/>
      <p:italic r:id="rId9"/>
    </p:embeddedFont>
    <p:embeddedFont>
      <p:font typeface="Helvetica" pitchFamily="2" charset="0"/>
      <p:regular r:id="rId10"/>
      <p:bold r:id="rId11"/>
      <p:italic r:id="rId12"/>
      <p:boldItalic r:id="rId13"/>
    </p:embeddedFont>
  </p:embeddedFont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320" userDrawn="1">
          <p15:clr>
            <a:srgbClr val="A4A3A4"/>
          </p15:clr>
        </p15:guide>
        <p15:guide id="2" pos="2069" userDrawn="1">
          <p15:clr>
            <a:srgbClr val="A4A3A4"/>
          </p15:clr>
        </p15:guide>
        <p15:guide id="3" pos="2341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notes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392300E-59B8-EE35-FC6A-43AB0AD735F4}" name="Ricardo Nilo Poyanco" initials="RNP" userId="3ada18ebad741824" providerId="Windows Liv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homas Dussarrat" initials="TD" lastIdx="5" clrIdx="0">
    <p:extLst>
      <p:ext uri="{19B8F6BF-5375-455C-9EA6-DF929625EA0E}">
        <p15:presenceInfo xmlns:p15="http://schemas.microsoft.com/office/powerpoint/2012/main" userId="abdcf33d1325a05d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918A"/>
    <a:srgbClr val="ADD9C8"/>
    <a:srgbClr val="BDD9D9"/>
    <a:srgbClr val="FFF0EE"/>
    <a:srgbClr val="FDE1DC"/>
    <a:srgbClr val="FAD1CC"/>
    <a:srgbClr val="FAC2BA"/>
    <a:srgbClr val="F0978A"/>
    <a:srgbClr val="EB877A"/>
    <a:srgbClr val="E6786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425" autoAdjust="0"/>
    <p:restoredTop sz="95647" autoAdjust="0"/>
  </p:normalViewPr>
  <p:slideViewPr>
    <p:cSldViewPr snapToGrid="0" showGuides="1">
      <p:cViewPr varScale="1">
        <p:scale>
          <a:sx n="43" d="100"/>
          <a:sy n="43" d="100"/>
        </p:scale>
        <p:origin x="2520" y="60"/>
      </p:cViewPr>
      <p:guideLst>
        <p:guide orient="horz" pos="5320"/>
        <p:guide pos="2069"/>
        <p:guide pos="2341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66" d="100"/>
        <a:sy n="66" d="100"/>
      </p:scale>
      <p:origin x="0" y="0"/>
    </p:cViewPr>
  </p:notesTextViewPr>
  <p:notesViewPr>
    <p:cSldViewPr snapToGrid="0" showGuides="1">
      <p:cViewPr varScale="1">
        <p:scale>
          <a:sx n="52" d="100"/>
          <a:sy n="52" d="100"/>
        </p:scale>
        <p:origin x="2862" y="84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5.fntdata"/><Relationship Id="rId13" Type="http://schemas.openxmlformats.org/officeDocument/2006/relationships/font" Target="fonts/font10.fntdata"/><Relationship Id="rId1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12" Type="http://schemas.openxmlformats.org/officeDocument/2006/relationships/font" Target="fonts/font9.fntdata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font" Target="fonts/font8.fntdata"/><Relationship Id="rId5" Type="http://schemas.openxmlformats.org/officeDocument/2006/relationships/font" Target="fonts/font2.fntdata"/><Relationship Id="rId15" Type="http://schemas.openxmlformats.org/officeDocument/2006/relationships/presProps" Target="presProps.xml"/><Relationship Id="rId10" Type="http://schemas.openxmlformats.org/officeDocument/2006/relationships/font" Target="fonts/font7.fntdata"/><Relationship Id="rId19" Type="http://schemas.microsoft.com/office/2018/10/relationships/authors" Target="authors.xml"/><Relationship Id="rId4" Type="http://schemas.openxmlformats.org/officeDocument/2006/relationships/font" Target="fonts/font1.fntdata"/><Relationship Id="rId9" Type="http://schemas.openxmlformats.org/officeDocument/2006/relationships/font" Target="fonts/font6.fntdata"/><Relationship Id="rId1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A9A0E6-6A3F-47B0-8DCE-2C95E7DF736B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 dirty="0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366D59-3C6A-44AB-90AA-10775F3CEE1B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3904919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366D59-3C6A-44AB-90AA-10775F3CEE1B}" type="slidenum">
              <a:rPr lang="fr-FR" smtClean="0"/>
              <a:t>1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4884054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8458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890043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7182141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556796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6544091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1061279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704695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10153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40631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80185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dirty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0452987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E547CF-0DD3-4634-A86F-58B5A3504A25}" type="datetimeFigureOut">
              <a:rPr lang="fr-FR" smtClean="0"/>
              <a:t>23/08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1077666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5" name="ZoneTexte 184">
            <a:extLst>
              <a:ext uri="{FF2B5EF4-FFF2-40B4-BE49-F238E27FC236}">
                <a16:creationId xmlns:a16="http://schemas.microsoft.com/office/drawing/2014/main" id="{51620FCE-0E03-4AF5-8199-FAEE4C9818F6}"/>
              </a:ext>
            </a:extLst>
          </p:cNvPr>
          <p:cNvSpPr txBox="1"/>
          <p:nvPr/>
        </p:nvSpPr>
        <p:spPr>
          <a:xfrm>
            <a:off x="552450" y="3751736"/>
            <a:ext cx="5754183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 | Setting the best threshold ratio. </a:t>
            </a:r>
            <a:r>
              <a:rPr lang="en-GB" sz="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Number of expanded reactions as a function of the ratio of the number of gene isoforms per reaction following: Atacama and Sister species comparison </a:t>
            </a:r>
            <a:r>
              <a:rPr lang="en-GB" sz="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a)</a:t>
            </a:r>
            <a:r>
              <a:rPr lang="en-GB" sz="8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GB" sz="8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or</a:t>
            </a:r>
            <a:r>
              <a:rPr lang="en-GB" sz="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pairwise comparisons </a:t>
            </a:r>
            <a:r>
              <a:rPr lang="en-GB" sz="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b)</a:t>
            </a:r>
            <a:r>
              <a:rPr lang="en-GB" sz="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Number of overexpressed reactions as a function of the ratio of the number of top-expressed genes per reaction following: Atacama and Sister species comparison </a:t>
            </a:r>
            <a:r>
              <a:rPr lang="en-GB" sz="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c)</a:t>
            </a:r>
            <a:r>
              <a:rPr lang="en-GB" sz="8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GB" sz="8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or</a:t>
            </a:r>
            <a:r>
              <a:rPr lang="en-GB" sz="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pairwise comparisons </a:t>
            </a:r>
            <a:r>
              <a:rPr lang="en-GB" sz="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d)</a:t>
            </a:r>
            <a:r>
              <a:rPr lang="en-GB" sz="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. A</a:t>
            </a:r>
            <a:r>
              <a:rPr lang="en-US" sz="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ratio of 3 indicates that at least 3 times more gene isoforms or top-expressed gene isoforms per reaction </a:t>
            </a:r>
            <a:r>
              <a:rPr lang="en-US" sz="8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were detected in </a:t>
            </a:r>
            <a:r>
              <a:rPr lang="en-US" sz="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he Atacama species.</a:t>
            </a:r>
            <a:endParaRPr lang="en-GB" sz="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8A472D7B-D1C5-4727-8B5F-F2552A5C67D8}"/>
              </a:ext>
            </a:extLst>
          </p:cNvPr>
          <p:cNvSpPr/>
          <p:nvPr/>
        </p:nvSpPr>
        <p:spPr>
          <a:xfrm>
            <a:off x="545550" y="532866"/>
            <a:ext cx="5760000" cy="3191409"/>
          </a:xfrm>
          <a:prstGeom prst="rect">
            <a:avLst/>
          </a:prstGeom>
          <a:noFill/>
          <a:ln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pic>
        <p:nvPicPr>
          <p:cNvPr id="3" name="Graphique 2">
            <a:extLst>
              <a:ext uri="{FF2B5EF4-FFF2-40B4-BE49-F238E27FC236}">
                <a16:creationId xmlns:a16="http://schemas.microsoft.com/office/drawing/2014/main" id="{DB2438A6-6DB0-DC53-1803-4E3F6A90713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568410" y="548106"/>
            <a:ext cx="5724000" cy="3078240"/>
          </a:xfrm>
          <a:prstGeom prst="rect">
            <a:avLst/>
          </a:prstGeom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99444747-B417-A248-88CE-FB7C97D298DE}"/>
              </a:ext>
            </a:extLst>
          </p:cNvPr>
          <p:cNvSpPr txBox="1"/>
          <p:nvPr/>
        </p:nvSpPr>
        <p:spPr>
          <a:xfrm>
            <a:off x="465458" y="47504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Helvetica" pitchFamily="2" charset="0"/>
              </a:rPr>
              <a:t>a</a:t>
            </a: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4B312C27-9A35-7E69-CB49-C712FC4DD060}"/>
              </a:ext>
            </a:extLst>
          </p:cNvPr>
          <p:cNvSpPr txBox="1"/>
          <p:nvPr/>
        </p:nvSpPr>
        <p:spPr>
          <a:xfrm>
            <a:off x="3339026" y="475046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Helvetica" pitchFamily="2" charset="0"/>
              </a:rPr>
              <a:t>b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C6B3D15A-2596-DB3B-9CA0-AACEC76B686C}"/>
              </a:ext>
            </a:extLst>
          </p:cNvPr>
          <p:cNvSpPr txBox="1"/>
          <p:nvPr/>
        </p:nvSpPr>
        <p:spPr>
          <a:xfrm>
            <a:off x="465458" y="1895386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Helvetica" pitchFamily="2" charset="0"/>
              </a:rPr>
              <a:t>c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44F124AC-00AA-084B-3A57-8BD9EE483F2E}"/>
              </a:ext>
            </a:extLst>
          </p:cNvPr>
          <p:cNvSpPr txBox="1"/>
          <p:nvPr/>
        </p:nvSpPr>
        <p:spPr>
          <a:xfrm>
            <a:off x="3339026" y="1895386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>
                <a:latin typeface="Helvetica" pitchFamily="2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284648004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webextensions/_rels/taskpanes.xml.rels><?xml version="1.0" encoding="UTF-8" standalone="yes"?>
<Relationships xmlns="http://schemas.openxmlformats.org/package/2006/relationships"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350" row="1">
    <wetp:webextensionref xmlns:r="http://schemas.openxmlformats.org/officeDocument/2006/relationships" r:id="rId1"/>
  </wetp:taskpane>
</wetp:taskpanes>
</file>

<file path=ppt/webextensions/webextension1.xml><?xml version="1.0" encoding="utf-8"?>
<we:webextension xmlns:we="http://schemas.microsoft.com/office/webextensions/webextension/2010/11" id="{9871AA9D-C2C8-41E6-9D93-8AF3495D5A01}">
  <we:reference id="wa200000113" version="1.0.0.0" store="fr-FR" storeType="OMEX"/>
  <we:alternateReferences>
    <we:reference id="wa200000113" version="1.0.0.0" store="WA200000113" storeType="OMEX"/>
  </we:alternateReferences>
  <we:properties/>
  <we:bindings/>
  <we:snapshot xmlns:r="http://schemas.openxmlformats.org/officeDocument/2006/relationships"/>
</we:webextension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728</TotalTime>
  <Words>109</Words>
  <Application>Microsoft Office PowerPoint</Application>
  <PresentationFormat>Format A4 (210 x 297 mm)</PresentationFormat>
  <Paragraphs>6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Calibri</vt:lpstr>
      <vt:lpstr>Helvetica</vt:lpstr>
      <vt:lpstr>Arial</vt:lpstr>
      <vt:lpstr>Calibri Light</vt:lpstr>
      <vt:lpstr>Times New Roman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homas Dussarrat</dc:creator>
  <cp:lastModifiedBy>Thomas Dussarrat</cp:lastModifiedBy>
  <cp:revision>1369</cp:revision>
  <dcterms:created xsi:type="dcterms:W3CDTF">2020-07-29T08:33:47Z</dcterms:created>
  <dcterms:modified xsi:type="dcterms:W3CDTF">2023-08-23T12:40:28Z</dcterms:modified>
</cp:coreProperties>
</file>